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. Miriam Schulz-Raffelt" initials="DMS" lastIdx="6" clrIdx="0">
    <p:extLst>
      <p:ext uri="{19B8F6BF-5375-455C-9EA6-DF929625EA0E}">
        <p15:presenceInfo xmlns:p15="http://schemas.microsoft.com/office/powerpoint/2012/main" userId="S-1-5-21-1036228674-4065426080-1347446729-9644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4660"/>
  </p:normalViewPr>
  <p:slideViewPr>
    <p:cSldViewPr>
      <p:cViewPr>
        <p:scale>
          <a:sx n="90" d="100"/>
          <a:sy n="90" d="100"/>
        </p:scale>
        <p:origin x="-198" y="-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441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944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5166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047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185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927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584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229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61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891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7953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439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251" y="804557"/>
            <a:ext cx="5762156" cy="4946635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458047" y="5820295"/>
            <a:ext cx="591244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ngement of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F/HSP22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ic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zom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5.5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vering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F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o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4 of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amydomonas reinhardtii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i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ck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ion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TA-boxes 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ck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ment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l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tter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’- and 3’-UTRs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denylatio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l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tter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al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t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os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F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NA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zusa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lamydomonas EST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brary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amizu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</a:t>
            </a:r>
            <a:r>
              <a:rPr lang="de-DE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0). 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o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lined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ding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genic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y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387311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Schroda</dc:creator>
  <cp:lastModifiedBy>Michael Schroda</cp:lastModifiedBy>
  <cp:revision>133</cp:revision>
  <cp:lastPrinted>2017-03-09T10:05:08Z</cp:lastPrinted>
  <dcterms:created xsi:type="dcterms:W3CDTF">2015-12-19T06:48:26Z</dcterms:created>
  <dcterms:modified xsi:type="dcterms:W3CDTF">2017-04-30T09:33:10Z</dcterms:modified>
</cp:coreProperties>
</file>